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gglin\OneDrive\2015_2018%20VittorioS\TronoD%202016\TE_derived%20regulatory%20loci%20iMPC%20Naive%20hESC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gglin\OneDrive\2015_2018%20VittorioS\TronoD%202016\TE_derived%20regulatory%20loci%20iMPC%20Naive%20hESC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gglin\OneDrive\2015_2018%20VittorioS\TronoD%202016\TE_derived%20regulatory%20loci%20iMPC%20Naive%20hESC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Percent of common TE-derived regulatory loci differentially expressed in </a:t>
            </a:r>
            <a:r>
              <a:rPr lang="en-US" dirty="0" smtClean="0"/>
              <a:t>MLME </a:t>
            </a:r>
            <a:r>
              <a:rPr lang="en-US" dirty="0"/>
              <a:t>vs Embryo &amp; Naïve vs Primed hESC (6924 TE loci linked with 2037 genes)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F$2</c:f>
              <c:strCache>
                <c:ptCount val="1"/>
                <c:pt idx="0">
                  <c:v>Percent of common TE-derived regulatory loci differentially expressed in iMPC vs Embryo &amp; Naïve vs Primed hESC (6924 TE loci linked with 2037 genes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6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E$3:$E$18</c:f>
              <c:strCache>
                <c:ptCount val="16"/>
                <c:pt idx="0">
                  <c:v>SINE/Alu</c:v>
                </c:pt>
                <c:pt idx="1">
                  <c:v>LINE/L1</c:v>
                </c:pt>
                <c:pt idx="2">
                  <c:v>SINE/MIR</c:v>
                </c:pt>
                <c:pt idx="3">
                  <c:v>LINE/L2</c:v>
                </c:pt>
                <c:pt idx="4">
                  <c:v>LTR/ERVL-MaLR</c:v>
                </c:pt>
                <c:pt idx="5">
                  <c:v>LTR7/HERVH</c:v>
                </c:pt>
                <c:pt idx="6">
                  <c:v>DNA/hAT-Charlie</c:v>
                </c:pt>
                <c:pt idx="7">
                  <c:v>SVA_D</c:v>
                </c:pt>
                <c:pt idx="8">
                  <c:v>DNA/TcMar-Tigger</c:v>
                </c:pt>
                <c:pt idx="9">
                  <c:v>SVA_F</c:v>
                </c:pt>
                <c:pt idx="10">
                  <c:v>LINE/CR1</c:v>
                </c:pt>
                <c:pt idx="11">
                  <c:v>SVA_C</c:v>
                </c:pt>
                <c:pt idx="12">
                  <c:v>SVA_E</c:v>
                </c:pt>
                <c:pt idx="13">
                  <c:v>LTR5.Hs/HERVK</c:v>
                </c:pt>
                <c:pt idx="14">
                  <c:v>SVA_B</c:v>
                </c:pt>
                <c:pt idx="15">
                  <c:v>SVA_A</c:v>
                </c:pt>
              </c:strCache>
            </c:strRef>
          </c:cat>
          <c:val>
            <c:numRef>
              <c:f>Sheet1!$F$3:$F$18</c:f>
              <c:numCache>
                <c:formatCode>0.0</c:formatCode>
                <c:ptCount val="16"/>
                <c:pt idx="0">
                  <c:v>65.691951360741172</c:v>
                </c:pt>
                <c:pt idx="1">
                  <c:v>75.83011583011583</c:v>
                </c:pt>
                <c:pt idx="2">
                  <c:v>65.997993981945839</c:v>
                </c:pt>
                <c:pt idx="3">
                  <c:v>70.714285714285722</c:v>
                </c:pt>
                <c:pt idx="4">
                  <c:v>70.564516129032256</c:v>
                </c:pt>
                <c:pt idx="5">
                  <c:v>71.662125340599459</c:v>
                </c:pt>
                <c:pt idx="6">
                  <c:v>69.586374695863753</c:v>
                </c:pt>
                <c:pt idx="7">
                  <c:v>97.942386831275712</c:v>
                </c:pt>
                <c:pt idx="8">
                  <c:v>78.63636363636364</c:v>
                </c:pt>
                <c:pt idx="9">
                  <c:v>97.142857142857139</c:v>
                </c:pt>
                <c:pt idx="10">
                  <c:v>75.609756097560975</c:v>
                </c:pt>
                <c:pt idx="11">
                  <c:v>100</c:v>
                </c:pt>
                <c:pt idx="12">
                  <c:v>100</c:v>
                </c:pt>
                <c:pt idx="13">
                  <c:v>75.555555555555557</c:v>
                </c:pt>
                <c:pt idx="14">
                  <c:v>88.571428571428569</c:v>
                </c:pt>
                <c:pt idx="15">
                  <c:v>85.7142857142857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71739696"/>
        <c:axId val="270981392"/>
      </c:barChart>
      <c:catAx>
        <c:axId val="27173969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0981392"/>
        <c:crosses val="autoZero"/>
        <c:auto val="1"/>
        <c:lblAlgn val="ctr"/>
        <c:lblOffset val="100"/>
        <c:noMultiLvlLbl val="0"/>
      </c:catAx>
      <c:valAx>
        <c:axId val="270981392"/>
        <c:scaling>
          <c:orientation val="minMax"/>
        </c:scaling>
        <c:delete val="1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crossAx val="2717396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400" dirty="0">
                <a:solidFill>
                  <a:sysClr val="windowText" lastClr="000000"/>
                </a:solidFill>
              </a:rPr>
              <a:t>Percent of common human-specific TE-derived regulatory </a:t>
            </a:r>
            <a:r>
              <a:rPr lang="en-US" sz="1400" dirty="0" smtClean="0">
                <a:solidFill>
                  <a:sysClr val="windowText" lastClr="000000"/>
                </a:solidFill>
              </a:rPr>
              <a:t>loci</a:t>
            </a:r>
            <a:r>
              <a:rPr lang="en-US" sz="1400" baseline="0" dirty="0" smtClean="0">
                <a:solidFill>
                  <a:sysClr val="windowText" lastClr="000000"/>
                </a:solidFill>
              </a:rPr>
              <a:t> </a:t>
            </a:r>
            <a:r>
              <a:rPr lang="en-US" sz="1400" dirty="0">
                <a:solidFill>
                  <a:sysClr val="windowText" lastClr="000000"/>
                </a:solidFill>
              </a:rPr>
              <a:t>differentially expressed in </a:t>
            </a:r>
            <a:r>
              <a:rPr lang="en-US" sz="1400" dirty="0" smtClean="0">
                <a:solidFill>
                  <a:sysClr val="windowText" lastClr="000000"/>
                </a:solidFill>
              </a:rPr>
              <a:t>MLME </a:t>
            </a:r>
            <a:r>
              <a:rPr lang="en-US" sz="1400" dirty="0">
                <a:solidFill>
                  <a:sysClr val="windowText" lastClr="000000"/>
                </a:solidFill>
              </a:rPr>
              <a:t>vs Embryo &amp; Naïve vs Primed hESC </a:t>
            </a:r>
            <a:r>
              <a:rPr lang="en-US" sz="1400" b="1" i="0" u="none" strike="noStrike" baseline="0" dirty="0">
                <a:effectLst/>
              </a:rPr>
              <a:t>(399 </a:t>
            </a:r>
            <a:r>
              <a:rPr lang="en-US" sz="1400" b="1" i="0" u="none" strike="noStrike" baseline="0" dirty="0" smtClean="0">
                <a:effectLst/>
              </a:rPr>
              <a:t>human-specific TE </a:t>
            </a:r>
            <a:r>
              <a:rPr lang="en-US" sz="1400" b="1" i="0" u="none" strike="noStrike" baseline="0" dirty="0">
                <a:effectLst/>
              </a:rPr>
              <a:t>loci linked with 340 </a:t>
            </a:r>
            <a:r>
              <a:rPr lang="en-US" sz="1400" b="1" i="0" u="none" strike="noStrike" baseline="0" dirty="0" smtClean="0">
                <a:effectLst/>
              </a:rPr>
              <a:t>genes)</a:t>
            </a:r>
            <a:endParaRPr lang="en-US" sz="1400" dirty="0">
              <a:solidFill>
                <a:sysClr val="windowText" lastClr="000000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2!$K$2</c:f>
              <c:strCache>
                <c:ptCount val="1"/>
                <c:pt idx="0">
                  <c:v>Percent of common human-specific TE-derived regulatory loci differentially expressed in iMPC vs Embryo &amp; Naïve vs Primed hESC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2!$J$3:$J$14</c:f>
              <c:strCache>
                <c:ptCount val="12"/>
                <c:pt idx="0">
                  <c:v>SVA_D</c:v>
                </c:pt>
                <c:pt idx="1">
                  <c:v>SVA_F</c:v>
                </c:pt>
                <c:pt idx="2">
                  <c:v>SVA_E</c:v>
                </c:pt>
                <c:pt idx="3">
                  <c:v>SINE/Alu</c:v>
                </c:pt>
                <c:pt idx="4">
                  <c:v>SVA_C</c:v>
                </c:pt>
                <c:pt idx="5">
                  <c:v>LTR5_Hs/HERVK</c:v>
                </c:pt>
                <c:pt idx="6">
                  <c:v>LTR7/HERVH</c:v>
                </c:pt>
                <c:pt idx="7">
                  <c:v>LTR/ERVL-MaLR</c:v>
                </c:pt>
                <c:pt idx="8">
                  <c:v>SVA_A</c:v>
                </c:pt>
                <c:pt idx="9">
                  <c:v>SVA_B</c:v>
                </c:pt>
                <c:pt idx="10">
                  <c:v>LINE/L1</c:v>
                </c:pt>
                <c:pt idx="11">
                  <c:v>LINE/L2</c:v>
                </c:pt>
              </c:strCache>
            </c:strRef>
          </c:cat>
          <c:val>
            <c:numRef>
              <c:f>Sheet2!$K$3:$K$14</c:f>
              <c:numCache>
                <c:formatCode>0.0</c:formatCode>
                <c:ptCount val="12"/>
                <c:pt idx="0">
                  <c:v>98.529411764705884</c:v>
                </c:pt>
                <c:pt idx="1">
                  <c:v>96.721311475409834</c:v>
                </c:pt>
                <c:pt idx="2">
                  <c:v>100</c:v>
                </c:pt>
                <c:pt idx="3">
                  <c:v>85.714285714285708</c:v>
                </c:pt>
                <c:pt idx="4">
                  <c:v>100</c:v>
                </c:pt>
                <c:pt idx="5">
                  <c:v>81.25</c:v>
                </c:pt>
                <c:pt idx="6">
                  <c:v>72.727272727272734</c:v>
                </c:pt>
                <c:pt idx="7">
                  <c:v>80</c:v>
                </c:pt>
                <c:pt idx="8">
                  <c:v>100</c:v>
                </c:pt>
                <c:pt idx="9">
                  <c:v>50</c:v>
                </c:pt>
                <c:pt idx="10">
                  <c:v>77.777777777777786</c:v>
                </c:pt>
                <c:pt idx="11">
                  <c:v>5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271697088"/>
        <c:axId val="273657760"/>
      </c:barChart>
      <c:catAx>
        <c:axId val="2716970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657760"/>
        <c:crosses val="autoZero"/>
        <c:auto val="1"/>
        <c:lblAlgn val="ctr"/>
        <c:lblOffset val="100"/>
        <c:noMultiLvlLbl val="0"/>
      </c:catAx>
      <c:valAx>
        <c:axId val="273657760"/>
        <c:scaling>
          <c:orientation val="minMax"/>
        </c:scaling>
        <c:delete val="1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crossAx val="2716970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600" b="1" dirty="0">
                <a:solidFill>
                  <a:sysClr val="windowText" lastClr="000000"/>
                </a:solidFill>
              </a:rPr>
              <a:t>Expression</a:t>
            </a:r>
            <a:r>
              <a:rPr lang="en-US" sz="1600" b="1" baseline="0" dirty="0">
                <a:solidFill>
                  <a:sysClr val="windowText" lastClr="000000"/>
                </a:solidFill>
              </a:rPr>
              <a:t> patterns of selected functionally-relevant TE-regulated protein-coding genes in </a:t>
            </a:r>
            <a:r>
              <a:rPr lang="en-US" sz="1600" b="1" baseline="0" dirty="0" smtClean="0">
                <a:solidFill>
                  <a:sysClr val="windowText" lastClr="000000"/>
                </a:solidFill>
              </a:rPr>
              <a:t>MLME </a:t>
            </a:r>
            <a:r>
              <a:rPr lang="en-US" sz="1600" b="1" baseline="0" dirty="0">
                <a:solidFill>
                  <a:sysClr val="windowText" lastClr="000000"/>
                </a:solidFill>
              </a:rPr>
              <a:t>during human preimplantation embryogenesis</a:t>
            </a:r>
            <a:endParaRPr lang="en-US" sz="1600" b="1" dirty="0">
              <a:solidFill>
                <a:sysClr val="windowText" lastClr="000000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012238458807393"/>
          <c:y val="0.21814342569934378"/>
          <c:w val="0.85375311813381505"/>
          <c:h val="0.69378862827967713"/>
        </c:manualLayout>
      </c:layout>
      <c:areaChart>
        <c:grouping val="standard"/>
        <c:varyColors val="0"/>
        <c:ser>
          <c:idx val="4"/>
          <c:order val="4"/>
          <c:tx>
            <c:strRef>
              <c:f>Sheet5!$W$16</c:f>
              <c:strCache>
                <c:ptCount val="1"/>
                <c:pt idx="0">
                  <c:v>Median_Embryo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accent1"/>
              </a:solidFill>
            </a:ln>
            <a:effectLst/>
          </c:spPr>
          <c:cat>
            <c:strRef>
              <c:f>Sheet5!$R$17:$R$23</c:f>
              <c:strCache>
                <c:ptCount val="7"/>
                <c:pt idx="0">
                  <c:v>RAD51</c:v>
                </c:pt>
                <c:pt idx="1">
                  <c:v>RAD54L</c:v>
                </c:pt>
                <c:pt idx="2">
                  <c:v>UBE2C</c:v>
                </c:pt>
                <c:pt idx="3">
                  <c:v>ZNF534</c:v>
                </c:pt>
                <c:pt idx="4">
                  <c:v>TRIM28</c:v>
                </c:pt>
                <c:pt idx="5">
                  <c:v>ZNF91</c:v>
                </c:pt>
                <c:pt idx="6">
                  <c:v>ZNF93</c:v>
                </c:pt>
              </c:strCache>
            </c:strRef>
          </c:cat>
          <c:val>
            <c:numRef>
              <c:f>Sheet5!$W$17:$W$23</c:f>
              <c:numCache>
                <c:formatCode>General</c:formatCode>
                <c:ptCount val="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2873008"/>
        <c:axId val="271231432"/>
      </c:areaChart>
      <c:barChart>
        <c:barDir val="col"/>
        <c:grouping val="clustered"/>
        <c:varyColors val="0"/>
        <c:ser>
          <c:idx val="0"/>
          <c:order val="0"/>
          <c:tx>
            <c:strRef>
              <c:f>Sheet5!$S$16</c:f>
              <c:strCache>
                <c:ptCount val="1"/>
                <c:pt idx="0">
                  <c:v>E4.lat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Sheet5!$R$17:$R$23</c:f>
              <c:strCache>
                <c:ptCount val="7"/>
                <c:pt idx="0">
                  <c:v>RAD51</c:v>
                </c:pt>
                <c:pt idx="1">
                  <c:v>RAD54L</c:v>
                </c:pt>
                <c:pt idx="2">
                  <c:v>UBE2C</c:v>
                </c:pt>
                <c:pt idx="3">
                  <c:v>ZNF534</c:v>
                </c:pt>
                <c:pt idx="4">
                  <c:v>TRIM28</c:v>
                </c:pt>
                <c:pt idx="5">
                  <c:v>ZNF91</c:v>
                </c:pt>
                <c:pt idx="6">
                  <c:v>ZNF93</c:v>
                </c:pt>
              </c:strCache>
            </c:strRef>
          </c:cat>
          <c:val>
            <c:numRef>
              <c:f>Sheet5!$S$17:$S$23</c:f>
              <c:numCache>
                <c:formatCode>0.0</c:formatCode>
                <c:ptCount val="7"/>
                <c:pt idx="0">
                  <c:v>3.6242990654205607</c:v>
                </c:pt>
                <c:pt idx="1">
                  <c:v>2.5984126984126981</c:v>
                </c:pt>
                <c:pt idx="2">
                  <c:v>10.105978705978705</c:v>
                </c:pt>
                <c:pt idx="3">
                  <c:v>19.32</c:v>
                </c:pt>
                <c:pt idx="4">
                  <c:v>4.5669531996179566</c:v>
                </c:pt>
                <c:pt idx="5">
                  <c:v>2.9722222222222223</c:v>
                </c:pt>
                <c:pt idx="6">
                  <c:v>2.4156862745098042</c:v>
                </c:pt>
              </c:numCache>
            </c:numRef>
          </c:val>
        </c:ser>
        <c:ser>
          <c:idx val="1"/>
          <c:order val="1"/>
          <c:tx>
            <c:strRef>
              <c:f>Sheet5!$T$16</c:f>
              <c:strCache>
                <c:ptCount val="1"/>
                <c:pt idx="0">
                  <c:v>E5.early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5!$R$17:$R$23</c:f>
              <c:strCache>
                <c:ptCount val="7"/>
                <c:pt idx="0">
                  <c:v>RAD51</c:v>
                </c:pt>
                <c:pt idx="1">
                  <c:v>RAD54L</c:v>
                </c:pt>
                <c:pt idx="2">
                  <c:v>UBE2C</c:v>
                </c:pt>
                <c:pt idx="3">
                  <c:v>ZNF534</c:v>
                </c:pt>
                <c:pt idx="4">
                  <c:v>TRIM28</c:v>
                </c:pt>
                <c:pt idx="5">
                  <c:v>ZNF91</c:v>
                </c:pt>
                <c:pt idx="6">
                  <c:v>ZNF93</c:v>
                </c:pt>
              </c:strCache>
            </c:strRef>
          </c:cat>
          <c:val>
            <c:numRef>
              <c:f>Sheet5!$T$17:$T$23</c:f>
              <c:numCache>
                <c:formatCode>0.0</c:formatCode>
                <c:ptCount val="7"/>
                <c:pt idx="0">
                  <c:v>4.8629283489096577</c:v>
                </c:pt>
                <c:pt idx="1">
                  <c:v>1.7301587301587302</c:v>
                </c:pt>
                <c:pt idx="2">
                  <c:v>5.559377559377559</c:v>
                </c:pt>
                <c:pt idx="3">
                  <c:v>15.2</c:v>
                </c:pt>
                <c:pt idx="4">
                  <c:v>2.7548551416746259</c:v>
                </c:pt>
                <c:pt idx="5">
                  <c:v>2.4351851851851851</c:v>
                </c:pt>
                <c:pt idx="6">
                  <c:v>3.1546840958605666</c:v>
                </c:pt>
              </c:numCache>
            </c:numRef>
          </c:val>
        </c:ser>
        <c:ser>
          <c:idx val="2"/>
          <c:order val="2"/>
          <c:tx>
            <c:strRef>
              <c:f>Sheet5!$U$16</c:f>
              <c:strCache>
                <c:ptCount val="1"/>
                <c:pt idx="0">
                  <c:v>E5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5!$R$17:$R$23</c:f>
              <c:strCache>
                <c:ptCount val="7"/>
                <c:pt idx="0">
                  <c:v>RAD51</c:v>
                </c:pt>
                <c:pt idx="1">
                  <c:v>RAD54L</c:v>
                </c:pt>
                <c:pt idx="2">
                  <c:v>UBE2C</c:v>
                </c:pt>
                <c:pt idx="3">
                  <c:v>ZNF534</c:v>
                </c:pt>
                <c:pt idx="4">
                  <c:v>TRIM28</c:v>
                </c:pt>
                <c:pt idx="5">
                  <c:v>ZNF91</c:v>
                </c:pt>
                <c:pt idx="6">
                  <c:v>ZNF93</c:v>
                </c:pt>
              </c:strCache>
            </c:strRef>
          </c:cat>
          <c:val>
            <c:numRef>
              <c:f>Sheet5!$U$17:$U$23</c:f>
              <c:numCache>
                <c:formatCode>0.0</c:formatCode>
                <c:ptCount val="7"/>
                <c:pt idx="0">
                  <c:v>3.0997997329773033</c:v>
                </c:pt>
                <c:pt idx="1">
                  <c:v>2.518707482993197</c:v>
                </c:pt>
                <c:pt idx="2">
                  <c:v>3.7894582894582896</c:v>
                </c:pt>
                <c:pt idx="3">
                  <c:v>5.7428571428571438</c:v>
                </c:pt>
                <c:pt idx="4">
                  <c:v>2.8458862054850593</c:v>
                </c:pt>
                <c:pt idx="5">
                  <c:v>2.4880952380952381</c:v>
                </c:pt>
                <c:pt idx="6">
                  <c:v>3.0560224089635852</c:v>
                </c:pt>
              </c:numCache>
            </c:numRef>
          </c:val>
        </c:ser>
        <c:ser>
          <c:idx val="3"/>
          <c:order val="3"/>
          <c:tx>
            <c:strRef>
              <c:f>Sheet5!$V$16</c:f>
              <c:strCache>
                <c:ptCount val="1"/>
                <c:pt idx="0">
                  <c:v>E6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Sheet5!$R$17:$R$23</c:f>
              <c:strCache>
                <c:ptCount val="7"/>
                <c:pt idx="0">
                  <c:v>RAD51</c:v>
                </c:pt>
                <c:pt idx="1">
                  <c:v>RAD54L</c:v>
                </c:pt>
                <c:pt idx="2">
                  <c:v>UBE2C</c:v>
                </c:pt>
                <c:pt idx="3">
                  <c:v>ZNF534</c:v>
                </c:pt>
                <c:pt idx="4">
                  <c:v>TRIM28</c:v>
                </c:pt>
                <c:pt idx="5">
                  <c:v>ZNF91</c:v>
                </c:pt>
                <c:pt idx="6">
                  <c:v>ZNF93</c:v>
                </c:pt>
              </c:strCache>
            </c:strRef>
          </c:cat>
          <c:val>
            <c:numRef>
              <c:f>Sheet5!$V$17:$V$23</c:f>
              <c:numCache>
                <c:formatCode>0.0</c:formatCode>
                <c:ptCount val="7"/>
                <c:pt idx="0">
                  <c:v>1.0023364485981308</c:v>
                </c:pt>
                <c:pt idx="1">
                  <c:v>0.98677248677248675</c:v>
                </c:pt>
                <c:pt idx="2">
                  <c:v>0.60633360633360633</c:v>
                </c:pt>
                <c:pt idx="3">
                  <c:v>0.97333333333333327</c:v>
                </c:pt>
                <c:pt idx="4">
                  <c:v>1.4333014963387456</c:v>
                </c:pt>
                <c:pt idx="5">
                  <c:v>1.2685185185185184</c:v>
                </c:pt>
                <c:pt idx="6">
                  <c:v>1.26797385620915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72873008"/>
        <c:axId val="271231432"/>
      </c:barChart>
      <c:catAx>
        <c:axId val="272873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1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1231432"/>
        <c:crosses val="autoZero"/>
        <c:auto val="1"/>
        <c:lblAlgn val="ctr"/>
        <c:lblOffset val="100"/>
        <c:noMultiLvlLbl val="0"/>
      </c:catAx>
      <c:valAx>
        <c:axId val="271231432"/>
        <c:scaling>
          <c:orientation val="minMax"/>
          <c:max val="2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>
                    <a:solidFill>
                      <a:sysClr val="windowText" lastClr="000000"/>
                    </a:solidFill>
                  </a:rPr>
                  <a:t>Fold</a:t>
                </a:r>
                <a:r>
                  <a:rPr lang="en-US" sz="1800" b="1" baseline="0">
                    <a:solidFill>
                      <a:sysClr val="windowText" lastClr="000000"/>
                    </a:solidFill>
                  </a:rPr>
                  <a:t> expression changes</a:t>
                </a:r>
                <a:endParaRPr lang="en-US" sz="1800" b="1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2.4919677611626074E-2"/>
              <c:y val="0.3435438400664004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28730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2826</cdr:x>
      <cdr:y>0.65259</cdr:y>
    </cdr:from>
    <cdr:to>
      <cdr:x>0.83379</cdr:x>
      <cdr:y>0.69482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6310046" y="4101101"/>
          <a:ext cx="914400" cy="2654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600" b="1">
              <a:solidFill>
                <a:srgbClr val="FF0000"/>
              </a:solidFill>
            </a:rPr>
            <a:t>(n = 263)</a:t>
          </a:r>
        </a:p>
      </cdr:txBody>
    </cdr:sp>
  </cdr:relSizeAnchor>
  <cdr:relSizeAnchor xmlns:cdr="http://schemas.openxmlformats.org/drawingml/2006/chartDrawing">
    <cdr:from>
      <cdr:x>0.89124</cdr:x>
      <cdr:y>0.54623</cdr:y>
    </cdr:from>
    <cdr:to>
      <cdr:x>0.99677</cdr:x>
      <cdr:y>0.58846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7722171" y="3432710"/>
          <a:ext cx="914400" cy="2654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600" b="1">
              <a:solidFill>
                <a:srgbClr val="FF0000"/>
              </a:solidFill>
            </a:rPr>
            <a:t>(n = 238)</a:t>
          </a:r>
        </a:p>
      </cdr:txBody>
    </cdr:sp>
  </cdr:relSizeAnchor>
  <cdr:relSizeAnchor xmlns:cdr="http://schemas.openxmlformats.org/drawingml/2006/chartDrawing">
    <cdr:from>
      <cdr:x>0.75288</cdr:x>
      <cdr:y>0.21509</cdr:y>
    </cdr:from>
    <cdr:to>
      <cdr:x>0.85842</cdr:x>
      <cdr:y>0.25732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6523348" y="1351694"/>
          <a:ext cx="914455" cy="26538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600" b="1" dirty="0">
              <a:solidFill>
                <a:srgbClr val="FF0000"/>
              </a:solidFill>
            </a:rPr>
            <a:t>(n = 34)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88926</cdr:x>
      <cdr:y>0.91408</cdr:y>
    </cdr:from>
    <cdr:to>
      <cdr:x>0.9948</cdr:x>
      <cdr:y>0.9563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7705047" y="5744396"/>
          <a:ext cx="914400" cy="2654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600" b="1">
              <a:solidFill>
                <a:srgbClr val="FF0000"/>
              </a:solidFill>
            </a:rPr>
            <a:t>(n = 201)</a:t>
          </a:r>
        </a:p>
      </cdr:txBody>
    </cdr:sp>
  </cdr:relSizeAnchor>
  <cdr:relSizeAnchor xmlns:cdr="http://schemas.openxmlformats.org/drawingml/2006/chartDrawing">
    <cdr:from>
      <cdr:x>0.77958</cdr:x>
      <cdr:y>0.55168</cdr:y>
    </cdr:from>
    <cdr:to>
      <cdr:x>0.88511</cdr:x>
      <cdr:y>0.59391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6754688" y="3466958"/>
          <a:ext cx="914400" cy="2654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600" b="1">
              <a:solidFill>
                <a:srgbClr val="FF0000"/>
              </a:solidFill>
            </a:rPr>
            <a:t>(n = 13)</a:t>
          </a:r>
        </a:p>
      </cdr:txBody>
    </cdr:sp>
  </cdr:relSizeAnchor>
  <cdr:relSizeAnchor xmlns:cdr="http://schemas.openxmlformats.org/drawingml/2006/chartDrawing">
    <cdr:from>
      <cdr:x>0.72325</cdr:x>
      <cdr:y>0.47947</cdr:y>
    </cdr:from>
    <cdr:to>
      <cdr:x>0.82879</cdr:x>
      <cdr:y>0.52171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6266666" y="3013182"/>
          <a:ext cx="914400" cy="2654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600" b="1">
              <a:solidFill>
                <a:srgbClr val="FF0000"/>
              </a:solidFill>
            </a:rPr>
            <a:t>(n = 8)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20616</cdr:x>
      <cdr:y>0.70102</cdr:y>
    </cdr:from>
    <cdr:to>
      <cdr:x>0.25436</cdr:x>
      <cdr:y>0.87945</cdr:y>
    </cdr:to>
    <cdr:sp macro="" textlink="">
      <cdr:nvSpPr>
        <cdr:cNvPr id="2" name="TextBox 1"/>
        <cdr:cNvSpPr txBox="1"/>
      </cdr:nvSpPr>
      <cdr:spPr>
        <a:xfrm xmlns:a="http://schemas.openxmlformats.org/drawingml/2006/main" rot="16200000">
          <a:off x="1433895" y="4761098"/>
          <a:ext cx="1122166" cy="41759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600" b="1">
              <a:solidFill>
                <a:sysClr val="windowText" lastClr="000000"/>
              </a:solidFill>
            </a:rPr>
            <a:t>p = 0.005</a:t>
          </a:r>
        </a:p>
      </cdr:txBody>
    </cdr:sp>
  </cdr:relSizeAnchor>
  <cdr:relSizeAnchor xmlns:cdr="http://schemas.openxmlformats.org/drawingml/2006/chartDrawing">
    <cdr:from>
      <cdr:x>0.32665</cdr:x>
      <cdr:y>0.7031</cdr:y>
    </cdr:from>
    <cdr:to>
      <cdr:x>0.37485</cdr:x>
      <cdr:y>0.88153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2477728" y="4774146"/>
          <a:ext cx="1122166" cy="41759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600" b="1">
              <a:solidFill>
                <a:sysClr val="windowText" lastClr="000000"/>
              </a:solidFill>
            </a:rPr>
            <a:t>p = 0.03</a:t>
          </a:r>
        </a:p>
      </cdr:txBody>
    </cdr:sp>
  </cdr:relSizeAnchor>
  <cdr:relSizeAnchor xmlns:cdr="http://schemas.openxmlformats.org/drawingml/2006/chartDrawing">
    <cdr:from>
      <cdr:x>0.45014</cdr:x>
      <cdr:y>0.66783</cdr:y>
    </cdr:from>
    <cdr:to>
      <cdr:x>0.49834</cdr:x>
      <cdr:y>0.84626</cdr:y>
    </cdr:to>
    <cdr:sp macro="" textlink="">
      <cdr:nvSpPr>
        <cdr:cNvPr id="4" name="TextBox 1"/>
        <cdr:cNvSpPr txBox="1"/>
      </cdr:nvSpPr>
      <cdr:spPr>
        <a:xfrm xmlns:a="http://schemas.openxmlformats.org/drawingml/2006/main" rot="16200000">
          <a:off x="3547660" y="4552330"/>
          <a:ext cx="1122166" cy="41759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600" b="1">
              <a:solidFill>
                <a:sysClr val="windowText" lastClr="000000"/>
              </a:solidFill>
            </a:rPr>
            <a:t>p = 1.413E-05</a:t>
          </a:r>
        </a:p>
      </cdr:txBody>
    </cdr:sp>
  </cdr:relSizeAnchor>
  <cdr:relSizeAnchor xmlns:cdr="http://schemas.openxmlformats.org/drawingml/2006/chartDrawing">
    <cdr:from>
      <cdr:x>0.57363</cdr:x>
      <cdr:y>0.6865</cdr:y>
    </cdr:from>
    <cdr:to>
      <cdr:x>0.62183</cdr:x>
      <cdr:y>0.86493</cdr:y>
    </cdr:to>
    <cdr:sp macro="" textlink="">
      <cdr:nvSpPr>
        <cdr:cNvPr id="5" name="TextBox 1"/>
        <cdr:cNvSpPr txBox="1"/>
      </cdr:nvSpPr>
      <cdr:spPr>
        <a:xfrm xmlns:a="http://schemas.openxmlformats.org/drawingml/2006/main" rot="16200000">
          <a:off x="4617592" y="4669763"/>
          <a:ext cx="1122166" cy="41759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600" b="1">
              <a:solidFill>
                <a:sysClr val="windowText" lastClr="000000"/>
              </a:solidFill>
            </a:rPr>
            <a:t>p = 0.0002</a:t>
          </a:r>
        </a:p>
      </cdr:txBody>
    </cdr:sp>
  </cdr:relSizeAnchor>
  <cdr:relSizeAnchor xmlns:cdr="http://schemas.openxmlformats.org/drawingml/2006/chartDrawing">
    <cdr:from>
      <cdr:x>0.6911</cdr:x>
      <cdr:y>0.69065</cdr:y>
    </cdr:from>
    <cdr:to>
      <cdr:x>0.7393</cdr:x>
      <cdr:y>0.86908</cdr:y>
    </cdr:to>
    <cdr:sp macro="" textlink="">
      <cdr:nvSpPr>
        <cdr:cNvPr id="6" name="TextBox 1"/>
        <cdr:cNvSpPr txBox="1"/>
      </cdr:nvSpPr>
      <cdr:spPr>
        <a:xfrm xmlns:a="http://schemas.openxmlformats.org/drawingml/2006/main" rot="16200000">
          <a:off x="5635330" y="4695858"/>
          <a:ext cx="1122166" cy="41759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600" b="1">
              <a:solidFill>
                <a:sysClr val="windowText" lastClr="000000"/>
              </a:solidFill>
            </a:rPr>
            <a:t>p = 0.009</a:t>
          </a:r>
        </a:p>
      </cdr:txBody>
    </cdr:sp>
  </cdr:relSizeAnchor>
  <cdr:relSizeAnchor xmlns:cdr="http://schemas.openxmlformats.org/drawingml/2006/chartDrawing">
    <cdr:from>
      <cdr:x>0.8161</cdr:x>
      <cdr:y>0.69272</cdr:y>
    </cdr:from>
    <cdr:to>
      <cdr:x>0.8643</cdr:x>
      <cdr:y>0.87115</cdr:y>
    </cdr:to>
    <cdr:sp macro="" textlink="">
      <cdr:nvSpPr>
        <cdr:cNvPr id="7" name="TextBox 1"/>
        <cdr:cNvSpPr txBox="1"/>
      </cdr:nvSpPr>
      <cdr:spPr>
        <a:xfrm xmlns:a="http://schemas.openxmlformats.org/drawingml/2006/main" rot="16200000">
          <a:off x="6718310" y="4708906"/>
          <a:ext cx="1122166" cy="41759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600" b="1">
              <a:solidFill>
                <a:sysClr val="windowText" lastClr="000000"/>
              </a:solidFill>
            </a:rPr>
            <a:t>p = 0.127</a:t>
          </a:r>
        </a:p>
      </cdr:txBody>
    </cdr:sp>
  </cdr:relSizeAnchor>
  <cdr:relSizeAnchor xmlns:cdr="http://schemas.openxmlformats.org/drawingml/2006/chartDrawing">
    <cdr:from>
      <cdr:x>0.93659</cdr:x>
      <cdr:y>0.69272</cdr:y>
    </cdr:from>
    <cdr:to>
      <cdr:x>0.98479</cdr:x>
      <cdr:y>0.87115</cdr:y>
    </cdr:to>
    <cdr:sp macro="" textlink="">
      <cdr:nvSpPr>
        <cdr:cNvPr id="8" name="TextBox 1"/>
        <cdr:cNvSpPr txBox="1"/>
      </cdr:nvSpPr>
      <cdr:spPr>
        <a:xfrm xmlns:a="http://schemas.openxmlformats.org/drawingml/2006/main" rot="16200000">
          <a:off x="7762146" y="4708906"/>
          <a:ext cx="1122166" cy="41759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600" b="1">
              <a:solidFill>
                <a:sysClr val="windowText" lastClr="000000"/>
              </a:solidFill>
            </a:rPr>
            <a:t>p = 0.349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E6AFF-C56A-4AC1-B860-A0116AAA1D09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E8703-7725-45B0-9003-6CA8675B7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112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E6AFF-C56A-4AC1-B860-A0116AAA1D09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E8703-7725-45B0-9003-6CA8675B7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041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E6AFF-C56A-4AC1-B860-A0116AAA1D09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E8703-7725-45B0-9003-6CA8675B7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2504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E6AFF-C56A-4AC1-B860-A0116AAA1D09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E8703-7725-45B0-9003-6CA8675B7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496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E6AFF-C56A-4AC1-B860-A0116AAA1D09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E8703-7725-45B0-9003-6CA8675B7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42812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E6AFF-C56A-4AC1-B860-A0116AAA1D09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E8703-7725-45B0-9003-6CA8675B7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6603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E6AFF-C56A-4AC1-B860-A0116AAA1D09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E8703-7725-45B0-9003-6CA8675B7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4337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E6AFF-C56A-4AC1-B860-A0116AAA1D09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E8703-7725-45B0-9003-6CA8675B7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230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E6AFF-C56A-4AC1-B860-A0116AAA1D09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E8703-7725-45B0-9003-6CA8675B7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695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E6AFF-C56A-4AC1-B860-A0116AAA1D09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E8703-7725-45B0-9003-6CA8675B7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450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E6AFF-C56A-4AC1-B860-A0116AAA1D09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E8703-7725-45B0-9003-6CA8675B7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960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4E6AFF-C56A-4AC1-B860-A0116AAA1D09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4E8703-7725-45B0-9003-6CA8675B7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623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448574"/>
            <a:ext cx="9144000" cy="3061389"/>
          </a:xfrm>
        </p:spPr>
        <p:txBody>
          <a:bodyPr>
            <a:normAutofit/>
          </a:bodyPr>
          <a:lstStyle/>
          <a:p>
            <a:r>
              <a:rPr lang="en-US" sz="4400" b="1" dirty="0" smtClean="0"/>
              <a:t>Supplemental Figure S2. </a:t>
            </a:r>
            <a:br>
              <a:rPr lang="en-US" sz="4400" b="1" dirty="0" smtClean="0"/>
            </a:br>
            <a:r>
              <a:rPr lang="en-US" sz="4400" b="1" dirty="0" smtClean="0"/>
              <a:t>Concordant TE loci differentially regulated in MLME </a:t>
            </a:r>
            <a:r>
              <a:rPr lang="en-US" sz="4400" b="1" dirty="0" smtClean="0"/>
              <a:t>cells vs </a:t>
            </a:r>
            <a:r>
              <a:rPr lang="en-US" sz="4400" b="1" dirty="0" smtClean="0"/>
              <a:t>Embryo and Naïve vs Primed hESC</a:t>
            </a:r>
            <a:endParaRPr lang="en-US" sz="4400" b="1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Marked in red bars designate TE loci encoding SCAR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18913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37335090"/>
              </p:ext>
            </p:extLst>
          </p:nvPr>
        </p:nvGraphicFramePr>
        <p:xfrm>
          <a:off x="1763730" y="286820"/>
          <a:ext cx="8664539" cy="6284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2158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2233520"/>
              </p:ext>
            </p:extLst>
          </p:nvPr>
        </p:nvGraphicFramePr>
        <p:xfrm>
          <a:off x="1763730" y="286820"/>
          <a:ext cx="8664539" cy="6284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918564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8226710"/>
              </p:ext>
            </p:extLst>
          </p:nvPr>
        </p:nvGraphicFramePr>
        <p:xfrm>
          <a:off x="1763730" y="286820"/>
          <a:ext cx="8664539" cy="6284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98471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39</Words>
  <Application>Microsoft Office PowerPoint</Application>
  <PresentationFormat>Widescreen</PresentationFormat>
  <Paragraphs>2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Supplemental Figure S2.  Concordant TE loci differentially regulated in MLME cells vs Embryo and Naïve vs Primed hESC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ennadi Glinskii</dc:creator>
  <cp:lastModifiedBy>Guennadi Glinskii</cp:lastModifiedBy>
  <cp:revision>7</cp:revision>
  <dcterms:created xsi:type="dcterms:W3CDTF">2020-06-12T18:18:14Z</dcterms:created>
  <dcterms:modified xsi:type="dcterms:W3CDTF">2021-03-24T01:45:25Z</dcterms:modified>
</cp:coreProperties>
</file>